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7" r:id="rId1"/>
  </p:sldMasterIdLst>
  <p:handoutMasterIdLst>
    <p:handoutMasterId r:id="rId3"/>
  </p:handoutMasterIdLst>
  <p:sldIdLst>
    <p:sldId id="289" r:id="rId2"/>
  </p:sldIdLst>
  <p:sldSz cx="6858000" cy="9144000" type="screen4x3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aş, Gürbüz" initials="DG" lastIdx="3" clrIdx="0">
    <p:extLst>
      <p:ext uri="{19B8F6BF-5375-455C-9EA6-DF929625EA0E}">
        <p15:presenceInfo xmlns:p15="http://schemas.microsoft.com/office/powerpoint/2012/main" userId="S-1-5-21-503454387-1949045944-1556899496-9977" providerId="AD"/>
      </p:ext>
    </p:extLst>
  </p:cmAuthor>
  <p:cmAuthor id="2" name="Metges, Cornelia" initials="MC" lastIdx="1" clrIdx="1">
    <p:extLst>
      <p:ext uri="{19B8F6BF-5375-455C-9EA6-DF929625EA0E}">
        <p15:presenceInfo xmlns:p15="http://schemas.microsoft.com/office/powerpoint/2012/main" userId="S-1-5-21-503454387-1949045944-1556899496-1647" providerId="AD"/>
      </p:ext>
    </p:extLst>
  </p:cmAuthor>
  <p:cmAuthor id="3" name="Seyedalmoosavi, Seyed Mohammadmahdi" initials="SSM" lastIdx="1" clrIdx="2">
    <p:extLst>
      <p:ext uri="{19B8F6BF-5375-455C-9EA6-DF929625EA0E}">
        <p15:presenceInfo xmlns:p15="http://schemas.microsoft.com/office/powerpoint/2012/main" userId="Seyedalmoosavi, Seyed Mohammadmahdi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AF2E4"/>
    <a:srgbClr val="008AF2"/>
    <a:srgbClr val="8BF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9" d="100"/>
          <a:sy n="79" d="100"/>
        </p:scale>
        <p:origin x="2502" y="10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handoutMaster" Target="handoutMasters/handout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0CCA6D-885C-46BE-99B6-D7BE0AA3ADCF}" type="datetimeFigureOut">
              <a:rPr lang="en-US" smtClean="0"/>
              <a:t>7/13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B396086-4DF5-4C1A-9383-489DF13016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927858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8C841DE4-B32F-40E3-9F96-C2C98F208100}" type="datetime1">
              <a:rPr lang="en-US" smtClean="0"/>
              <a:pPr>
                <a:defRPr/>
              </a:pPr>
              <a:t>7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5288362D-1D0C-4593-A9CA-02F6DE5E30E4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77371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8C841DE4-B32F-40E3-9F96-C2C98F208100}" type="datetime1">
              <a:rPr lang="en-US" smtClean="0"/>
              <a:pPr>
                <a:defRPr/>
              </a:pPr>
              <a:t>7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D605C50B-E0C3-4BF6-8544-A9C566FA2995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76549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8C841DE4-B32F-40E3-9F96-C2C98F208100}" type="datetime1">
              <a:rPr lang="en-US" smtClean="0"/>
              <a:pPr>
                <a:defRPr/>
              </a:pPr>
              <a:t>7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543C7264-A86D-4D82-B02E-BD7B43AA2336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70188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8C841DE4-B32F-40E3-9F96-C2C98F208100}" type="datetime1">
              <a:rPr lang="en-US" smtClean="0"/>
              <a:pPr>
                <a:defRPr/>
              </a:pPr>
              <a:t>7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ABCC6F7-0F91-4441-BF97-A3AF72A48303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38365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8C841DE4-B32F-40E3-9F96-C2C98F208100}" type="datetime1">
              <a:rPr lang="en-US" smtClean="0"/>
              <a:pPr>
                <a:defRPr/>
              </a:pPr>
              <a:t>7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92A0F213-BB88-4223-AECB-E7C98DE4F91F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30426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8C841DE4-B32F-40E3-9F96-C2C98F208100}" type="datetime1">
              <a:rPr lang="en-US" smtClean="0"/>
              <a:pPr>
                <a:defRPr/>
              </a:pPr>
              <a:t>7/1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205F555C-B798-4584-9735-0D743CA03846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8363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8C841DE4-B32F-40E3-9F96-C2C98F208100}" type="datetime1">
              <a:rPr lang="en-US" smtClean="0"/>
              <a:pPr>
                <a:defRPr/>
              </a:pPr>
              <a:t>7/13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0978F460-E66C-4863-AF15-C4A2426FA0FC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97597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8C841DE4-B32F-40E3-9F96-C2C98F208100}" type="datetime1">
              <a:rPr lang="en-US" smtClean="0"/>
              <a:pPr>
                <a:defRPr/>
              </a:pPr>
              <a:t>7/13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4722F1AA-6A28-4DC7-B08E-B0B6C8267958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93819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8C841DE4-B32F-40E3-9F96-C2C98F208100}" type="datetime1">
              <a:rPr lang="en-US" smtClean="0"/>
              <a:pPr>
                <a:defRPr/>
              </a:pPr>
              <a:t>7/13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4B9ED24E-8843-4C3A-ACB3-45594BD874A2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90433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8C841DE4-B32F-40E3-9F96-C2C98F208100}" type="datetime1">
              <a:rPr lang="en-US" smtClean="0"/>
              <a:pPr>
                <a:defRPr/>
              </a:pPr>
              <a:t>7/1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05017539-FB6A-4BCE-86F3-A1A36D159024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16918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8C841DE4-B32F-40E3-9F96-C2C98F208100}" type="datetime1">
              <a:rPr lang="en-US" smtClean="0"/>
              <a:pPr>
                <a:defRPr/>
              </a:pPr>
              <a:t>7/1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1879D9DB-D59E-4BB7-A5D4-1AE4FF1B3F06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05400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8C841DE4-B32F-40E3-9F96-C2C98F208100}" type="datetime1">
              <a:rPr lang="en-US" smtClean="0"/>
              <a:pPr>
                <a:defRPr/>
              </a:pPr>
              <a:t>7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CDB8A7E9-E4BA-4136-A86B-FC9378F0562E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8791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8" r:id="rId1"/>
    <p:sldLayoutId id="2147483699" r:id="rId2"/>
    <p:sldLayoutId id="2147483700" r:id="rId3"/>
    <p:sldLayoutId id="2147483701" r:id="rId4"/>
    <p:sldLayoutId id="2147483702" r:id="rId5"/>
    <p:sldLayoutId id="2147483703" r:id="rId6"/>
    <p:sldLayoutId id="2147483704" r:id="rId7"/>
    <p:sldLayoutId id="2147483705" r:id="rId8"/>
    <p:sldLayoutId id="2147483706" r:id="rId9"/>
    <p:sldLayoutId id="2147483707" r:id="rId10"/>
    <p:sldLayoutId id="2147483708" r:id="rId11"/>
  </p:sldLayoutIdLst>
  <p:hf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ABCC6F7-0F91-4441-BF97-A3AF72A48303}" type="slidenum">
              <a:rPr lang="en-US" smtClean="0"/>
              <a:pPr>
                <a:defRPr/>
              </a:pPr>
              <a:t>1</a:t>
            </a:fld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109728" y="8165736"/>
            <a:ext cx="6701494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</a:t>
            </a:r>
            <a:r>
              <a:rPr lang="en-US" sz="14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4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fects of increasing levels of black soldier fly in broiler rations on feed conversion ratio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 protein conversion ratio (B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energy conversion ratio (C) during the experimental weeks. N = 144 (4 treatments each with 6 replicate pens measured at 6 weeks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(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 = 6 per group).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alues are LSM with their SE.</a:t>
            </a:r>
            <a:endParaRPr lang="en-US" sz="1400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r="5429"/>
          <a:stretch/>
        </p:blipFill>
        <p:spPr>
          <a:xfrm>
            <a:off x="285359" y="99558"/>
            <a:ext cx="6350231" cy="80661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142822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2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Leibniz-Institut für Nutztierbiologie (FBN)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eyedalmossavi, Seyed Mohammadmahdi</dc:creator>
  <cp:lastModifiedBy>Seyedalmoosavi, Seyed Mohammadmahdi</cp:lastModifiedBy>
  <cp:revision>183</cp:revision>
  <cp:lastPrinted>2022-01-18T09:07:24Z</cp:lastPrinted>
  <dcterms:created xsi:type="dcterms:W3CDTF">2021-11-10T16:13:10Z</dcterms:created>
  <dcterms:modified xsi:type="dcterms:W3CDTF">2022-07-13T13:11:17Z</dcterms:modified>
</cp:coreProperties>
</file>